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924" y="-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9EF62A-B9B3-491D-AEB9-A8C3BAAA487B}" type="datetimeFigureOut">
              <a:rPr lang="fr-FR" smtClean="0"/>
              <a:t>07/07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4DB7AF-167E-4490-8FEA-190D9F324909}" type="slidenum">
              <a:rPr lang="fr-FR" smtClean="0"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51520" y="6002704"/>
            <a:ext cx="864096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. </a:t>
            </a:r>
            <a:r>
              <a:rPr lang="fr-FR" sz="11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lang="fr-FR" sz="11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dentification of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ature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184T46 as 4-pyridoxic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id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cas 82-82-6);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d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es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standard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lecule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lue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es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erimental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ple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p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ull MS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romatograms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fr-FR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ddle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ull MS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ectra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sz="11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ttom</a:t>
            </a:r>
            <a:r>
              <a:rPr lang="fr-F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S/MS </a:t>
            </a:r>
            <a:r>
              <a:rPr lang="fr-F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ectra</a:t>
            </a:r>
            <a:endParaRPr lang="fr-FR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96173" y="260648"/>
            <a:ext cx="6751655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8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196173" y="2276872"/>
            <a:ext cx="6751655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9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196173" y="4149280"/>
            <a:ext cx="6751655" cy="180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40</Words>
  <Application>Microsoft Office PowerPoint</Application>
  <PresentationFormat>Affichage à l'écran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Gaelle</dc:creator>
  <cp:lastModifiedBy>GRISON Stephane</cp:lastModifiedBy>
  <cp:revision>12</cp:revision>
  <dcterms:created xsi:type="dcterms:W3CDTF">2014-11-17T10:21:09Z</dcterms:created>
  <dcterms:modified xsi:type="dcterms:W3CDTF">2016-07-07T13:31:27Z</dcterms:modified>
</cp:coreProperties>
</file>